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3400" y="744120"/>
            <a:ext cx="279072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885136-03AE-49F6-B06C-73BA91ACDD7B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egnaposto numero diapositiva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319923-6854-4812-90C1-59C3105EB95E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B5420-98DF-483F-8CEF-518AE5B4FC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038998-D68A-4203-9D4C-C643B0BF65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C3393-C16A-423F-8E49-C3420B3490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159CE-EF20-498B-911C-A6DAA9901D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4A0A0-5B00-4DF4-BC8A-7FBF76C874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1AFBB-05B4-472E-88A6-86C0A88F64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29A42-35F9-40CD-93E1-4E6943780D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A1861-807E-487B-977F-F5314EB3BD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8721A-E91E-487B-ADA7-C41E0B189C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AA877C-9CCC-43EF-8D88-5A7475D292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24BE53-F05B-4C3E-A3DA-301BD9F4A0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760EC5-4A61-4417-AC7D-07DF8B7468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F6BEDC-82FF-480D-A89E-4A81139154F3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asellaDiTesto 3"/>
          <p:cNvSpPr/>
          <p:nvPr/>
        </p:nvSpPr>
        <p:spPr>
          <a:xfrm>
            <a:off x="-316080" y="6588000"/>
            <a:ext cx="706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Lo Iacono et al., Fig. S5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39"/>
          <p:cNvSpPr/>
          <p:nvPr/>
        </p:nvSpPr>
        <p:spPr>
          <a:xfrm>
            <a:off x="722160" y="4524480"/>
            <a:ext cx="27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sellaDiTesto 40"/>
          <p:cNvSpPr/>
          <p:nvPr/>
        </p:nvSpPr>
        <p:spPr>
          <a:xfrm>
            <a:off x="506520" y="4091040"/>
            <a:ext cx="49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4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CasellaDiTesto 41"/>
          <p:cNvSpPr/>
          <p:nvPr/>
        </p:nvSpPr>
        <p:spPr>
          <a:xfrm>
            <a:off x="523800" y="364500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8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42"/>
          <p:cNvSpPr/>
          <p:nvPr/>
        </p:nvSpPr>
        <p:spPr>
          <a:xfrm>
            <a:off x="403200" y="3186000"/>
            <a:ext cx="59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12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asellaDiTesto 43"/>
          <p:cNvSpPr/>
          <p:nvPr/>
        </p:nvSpPr>
        <p:spPr>
          <a:xfrm>
            <a:off x="404640" y="2747880"/>
            <a:ext cx="59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16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sellaDiTesto 8"/>
          <p:cNvSpPr/>
          <p:nvPr/>
        </p:nvSpPr>
        <p:spPr>
          <a:xfrm>
            <a:off x="1174320" y="266868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  <a:ea typeface="Arial"/>
              </a:rPr>
              <a:t>ES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CasellaDiTesto 9"/>
          <p:cNvSpPr/>
          <p:nvPr/>
        </p:nvSpPr>
        <p:spPr>
          <a:xfrm rot="16200000">
            <a:off x="-361080" y="3601800"/>
            <a:ext cx="1489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Locomotor activity (c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sellaDiTesto 9"/>
          <p:cNvSpPr/>
          <p:nvPr/>
        </p:nvSpPr>
        <p:spPr>
          <a:xfrm>
            <a:off x="2492280" y="4108320"/>
            <a:ext cx="93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Vehic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ttangolo 11"/>
          <p:cNvSpPr/>
          <p:nvPr/>
        </p:nvSpPr>
        <p:spPr>
          <a:xfrm>
            <a:off x="2395440" y="4156200"/>
            <a:ext cx="142920" cy="1555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ttangolo 12"/>
          <p:cNvSpPr/>
          <p:nvPr/>
        </p:nvSpPr>
        <p:spPr>
          <a:xfrm>
            <a:off x="2395440" y="4356000"/>
            <a:ext cx="142920" cy="144720"/>
          </a:xfrm>
          <a:prstGeom prst="rect">
            <a:avLst/>
          </a:prstGeom>
          <a:solidFill>
            <a:srgbClr val="7f7f7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CasellaDiTesto 86"/>
          <p:cNvSpPr/>
          <p:nvPr/>
        </p:nvSpPr>
        <p:spPr>
          <a:xfrm>
            <a:off x="587520" y="22683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CasellaDiTesto 10"/>
          <p:cNvSpPr/>
          <p:nvPr/>
        </p:nvSpPr>
        <p:spPr>
          <a:xfrm>
            <a:off x="2498760" y="4302000"/>
            <a:ext cx="133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Resvera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Grafico 20" descr=""/>
          <p:cNvPicPr/>
          <p:nvPr/>
        </p:nvPicPr>
        <p:blipFill>
          <a:blip r:embed="rId1"/>
          <a:stretch/>
        </p:blipFill>
        <p:spPr>
          <a:xfrm>
            <a:off x="847800" y="2724120"/>
            <a:ext cx="1944720" cy="2073240"/>
          </a:xfrm>
          <a:prstGeom prst="rect">
            <a:avLst/>
          </a:prstGeom>
          <a:ln w="0">
            <a:noFill/>
          </a:ln>
        </p:spPr>
      </p:pic>
      <p:grpSp>
        <p:nvGrpSpPr>
          <p:cNvPr id="62" name="Gruppo 1"/>
          <p:cNvGrpSpPr/>
          <p:nvPr/>
        </p:nvGrpSpPr>
        <p:grpSpPr>
          <a:xfrm>
            <a:off x="3568680" y="2327400"/>
            <a:ext cx="3532320" cy="2460600"/>
            <a:chOff x="3568680" y="2327400"/>
            <a:chExt cx="3532320" cy="2460600"/>
          </a:xfrm>
        </p:grpSpPr>
        <p:sp>
          <p:nvSpPr>
            <p:cNvPr id="63" name="CasellaDiTesto 86"/>
            <p:cNvSpPr/>
            <p:nvPr/>
          </p:nvSpPr>
          <p:spPr>
            <a:xfrm>
              <a:off x="3927240" y="2327400"/>
              <a:ext cx="365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4" name="Grafico 16" descr=""/>
            <p:cNvPicPr/>
            <p:nvPr/>
          </p:nvPicPr>
          <p:blipFill>
            <a:blip r:embed="rId2"/>
            <a:stretch/>
          </p:blipFill>
          <p:spPr>
            <a:xfrm>
              <a:off x="4145400" y="2724480"/>
              <a:ext cx="1944360" cy="2063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CasellaDiTesto 39"/>
            <p:cNvSpPr/>
            <p:nvPr/>
          </p:nvSpPr>
          <p:spPr>
            <a:xfrm>
              <a:off x="4029840" y="4504320"/>
              <a:ext cx="27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CasellaDiTesto 40"/>
            <p:cNvSpPr/>
            <p:nvPr/>
          </p:nvSpPr>
          <p:spPr>
            <a:xfrm>
              <a:off x="3814560" y="4072680"/>
              <a:ext cx="492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CasellaDiTesto 41"/>
            <p:cNvSpPr/>
            <p:nvPr/>
          </p:nvSpPr>
          <p:spPr>
            <a:xfrm>
              <a:off x="3831480" y="3627000"/>
              <a:ext cx="47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CasellaDiTesto 42"/>
            <p:cNvSpPr/>
            <p:nvPr/>
          </p:nvSpPr>
          <p:spPr>
            <a:xfrm>
              <a:off x="3711960" y="3167640"/>
              <a:ext cx="59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CasellaDiTesto 43"/>
            <p:cNvSpPr/>
            <p:nvPr/>
          </p:nvSpPr>
          <p:spPr>
            <a:xfrm>
              <a:off x="3713400" y="2730240"/>
              <a:ext cx="59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0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CasellaDiTesto 25"/>
            <p:cNvSpPr/>
            <p:nvPr/>
          </p:nvSpPr>
          <p:spPr>
            <a:xfrm rot="16200000">
              <a:off x="2946960" y="3583440"/>
              <a:ext cx="148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comotor activity (c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CasellaDiTesto 26"/>
            <p:cNvSpPr/>
            <p:nvPr/>
          </p:nvSpPr>
          <p:spPr>
            <a:xfrm>
              <a:off x="4368960" y="2651400"/>
              <a:ext cx="67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CasellaDiTesto 9"/>
            <p:cNvSpPr/>
            <p:nvPr/>
          </p:nvSpPr>
          <p:spPr>
            <a:xfrm>
              <a:off x="5760360" y="4089600"/>
              <a:ext cx="93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ttangolo 28"/>
            <p:cNvSpPr/>
            <p:nvPr/>
          </p:nvSpPr>
          <p:spPr>
            <a:xfrm>
              <a:off x="5663520" y="4137480"/>
              <a:ext cx="142560" cy="1551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ttangolo 29"/>
            <p:cNvSpPr/>
            <p:nvPr/>
          </p:nvSpPr>
          <p:spPr>
            <a:xfrm>
              <a:off x="5663520" y="4337280"/>
              <a:ext cx="142560" cy="1440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CasellaDiTesto 10"/>
            <p:cNvSpPr/>
            <p:nvPr/>
          </p:nvSpPr>
          <p:spPr>
            <a:xfrm>
              <a:off x="5766840" y="4284000"/>
              <a:ext cx="1334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lisista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01T14:25:54Z</dcterms:created>
  <dc:creator>User</dc:creator>
  <dc:description/>
  <dc:language>en-US</dc:language>
  <cp:lastModifiedBy>L.Latha</cp:lastModifiedBy>
  <cp:lastPrinted>2014-12-01T14:51:33Z</cp:lastPrinted>
  <dcterms:modified xsi:type="dcterms:W3CDTF">2015-08-18T10:40:04Z</dcterms:modified>
  <cp:revision>35</cp:revision>
  <dc:subject/>
  <dc:title>Presentazione standard di PowerPoint</dc:title>
</cp:coreProperties>
</file>